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png" ContentType="image/png"/>
  <Override PartName="/ppt/media/image8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CA09B5-7369-4795-9048-579A5E9F94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99208-3533-4953-A702-99CA1637D2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88F04-BB0C-4597-8768-00B2C1984C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3B847-3AB0-4077-B250-545AC48410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0597BA-7CAB-4F12-8FB5-0B858CDDB9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9152B-3B36-424F-BC97-56D73D80C7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7B0ED-CB79-481F-AC04-9B16BDA536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8806A-A3AE-4237-84CE-F89AF8C302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A5486A-22D5-42C3-A081-383E102A59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A3C4C7-E154-42DF-BD21-53C14A7C7A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B997E-B1B2-48BC-97F5-6646BF1F72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ACE71-45DE-4FA3-8AAB-F0CE643752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E67E449-CFA0-4C38-BFFD-02DF1AD4474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339920" y="189000"/>
            <a:ext cx="6400440" cy="6322680"/>
            <a:chOff x="1339920" y="189000"/>
            <a:chExt cx="6400440" cy="6322680"/>
          </a:xfrm>
        </p:grpSpPr>
        <p:pic>
          <p:nvPicPr>
            <p:cNvPr id="42" name="" descr=""/>
            <p:cNvPicPr/>
            <p:nvPr/>
          </p:nvPicPr>
          <p:blipFill>
            <a:blip r:embed="rId1">
              <a:lum contrast="18000"/>
            </a:blip>
            <a:srcRect l="7013" t="0" r="5390" b="9628"/>
            <a:stretch/>
          </p:blipFill>
          <p:spPr>
            <a:xfrm>
              <a:off x="1454040" y="225720"/>
              <a:ext cx="1907280" cy="146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>
              <a:lum contrast="94000"/>
            </a:blip>
            <a:srcRect l="5053" t="0" r="0" b="9628"/>
            <a:stretch/>
          </p:blipFill>
          <p:spPr>
            <a:xfrm>
              <a:off x="1437480" y="3426120"/>
              <a:ext cx="2057760" cy="147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>
              <a:lum contrast="18000"/>
            </a:blip>
            <a:srcRect l="7546" t="0" r="0" b="9628"/>
            <a:stretch/>
          </p:blipFill>
          <p:spPr>
            <a:xfrm>
              <a:off x="1454040" y="1825920"/>
              <a:ext cx="2009520" cy="14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rcRect l="0" t="0" r="0" b="9628"/>
            <a:stretch/>
          </p:blipFill>
          <p:spPr>
            <a:xfrm>
              <a:off x="1339920" y="5040000"/>
              <a:ext cx="2171880" cy="147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5">
              <a:lum contrast="18000"/>
            </a:blip>
            <a:srcRect l="5255" t="0" r="0" b="9628"/>
            <a:stretch/>
          </p:blipFill>
          <p:spPr>
            <a:xfrm>
              <a:off x="3511800" y="225720"/>
              <a:ext cx="2057040" cy="147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6">
              <a:lum contrast="94000"/>
            </a:blip>
            <a:srcRect l="0" t="0" r="0" b="9628"/>
            <a:stretch/>
          </p:blipFill>
          <p:spPr>
            <a:xfrm>
              <a:off x="3397320" y="3440160"/>
              <a:ext cx="2171520" cy="147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7">
              <a:lum contrast="18000"/>
            </a:blip>
            <a:srcRect l="0" t="0" r="0" b="9628"/>
            <a:stretch/>
          </p:blipFill>
          <p:spPr>
            <a:xfrm>
              <a:off x="5568840" y="189000"/>
              <a:ext cx="2171520" cy="147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8">
              <a:lum contrast="18000"/>
            </a:blip>
            <a:srcRect l="0" t="0" r="0" b="9628"/>
            <a:stretch/>
          </p:blipFill>
          <p:spPr>
            <a:xfrm>
              <a:off x="5568840" y="1839600"/>
              <a:ext cx="2171520" cy="147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9">
              <a:lum contrast="94000"/>
            </a:blip>
            <a:srcRect l="0" t="0" r="0" b="9628"/>
            <a:stretch/>
          </p:blipFill>
          <p:spPr>
            <a:xfrm>
              <a:off x="5568840" y="3426120"/>
              <a:ext cx="2171520" cy="1471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10">
              <a:lum contrast="18000"/>
            </a:blip>
            <a:srcRect l="0" t="0" r="0" b="9628"/>
            <a:stretch/>
          </p:blipFill>
          <p:spPr>
            <a:xfrm>
              <a:off x="3397320" y="1825920"/>
              <a:ext cx="2171520" cy="1471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2" name=""/>
          <p:cNvSpPr/>
          <p:nvPr/>
        </p:nvSpPr>
        <p:spPr>
          <a:xfrm>
            <a:off x="6873120" y="6086520"/>
            <a:ext cx="129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igure S12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1535400" y="6524640"/>
            <a:ext cx="1752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Times New Roman"/>
              </a:rPr>
              <a:t>clpA clpX   nifS  pep  pyrG recG  rplB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3584520" y="4941720"/>
            <a:ext cx="1778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Times New Roman"/>
              </a:rPr>
              <a:t>clpA  clpX  nifS  pep   pyrG recG  rplB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5757840" y="4941720"/>
            <a:ext cx="1778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Times New Roman"/>
              </a:rPr>
              <a:t>clpA  clpX  nifS  pep   pyrG  recG rplB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7:52:09Z</dcterms:modified>
  <cp:revision>59</cp:revision>
  <dc:subject/>
  <dc:title>Slide 1</dc:title>
</cp:coreProperties>
</file>